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3" d="100"/>
          <a:sy n="153" d="100"/>
        </p:scale>
        <p:origin x="576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467AAAA-878E-ACC4-48CA-8E1C0B80FF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0A9AC87-3FAD-BA66-2018-46436D1F39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D4478AC-DE33-FCF5-5F4C-38D62482D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DF163-5251-4D3D-AE0C-30CF899358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E07E70C-69C5-B369-1A20-1858DE761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41FAA82-07D9-5A2A-65EB-98568D7C9D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DE07-21A0-4561-A9C8-47887C3BA2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3159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DF4226-52B5-B2F3-DF94-DEB166C161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6D0B527-F09D-D135-4023-121738CCE0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E02D584-91F5-C71F-4255-EF7B8BDBBB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DF163-5251-4D3D-AE0C-30CF899358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3EE854-A032-B769-8CCF-43DC7AAE1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5AFECD1-440C-1143-CBC3-480D815EF6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DE07-21A0-4561-A9C8-47887C3BA2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0431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4CC38DC-38BB-7607-7797-FFC23FE4F3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09F632C-1F98-7AC9-85CD-B6AEA8ABCD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03A422-5466-8037-9A85-D9D105F26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DF163-5251-4D3D-AE0C-30CF899358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EA1452C-8137-40A8-350E-B3FEEB6E17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BF35B95-FB67-1C18-3691-6B9DC4730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DE07-21A0-4561-A9C8-47887C3BA2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4015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AA1817-0480-6392-2395-A3CB5D61E8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048A7B5-34FD-6DB1-1A0E-519CEC0EC0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11C8BB-395D-4FC3-35D1-DE495AA75F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DF163-5251-4D3D-AE0C-30CF899358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923E57F-6997-B7FD-0FCD-58CA24A8E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E719CB1-50A7-D042-582E-AE673C172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DE07-21A0-4561-A9C8-47887C3BA2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0763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356862D-B4C7-7650-F48A-DC47CC6FEE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7108C0F-1B9D-EAFC-7CDD-ADF45AFD1D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D8D114-AA95-BD0B-97F8-206746FE9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DF163-5251-4D3D-AE0C-30CF899358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62E160-0E3A-3D82-93DC-1FD491EA9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DCC24D-C5C4-66F2-C618-4BFAFAF396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DE07-21A0-4561-A9C8-47887C3BA2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3582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273312-29F0-13B2-CC7C-F8B9506BB0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FC06967-5F98-CA69-0523-A45F3F7B62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AE95EA4-B7F5-9FDB-3F0B-6EFE42BF4E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8147137-4A0F-F8F7-4B37-475DED32D0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DF163-5251-4D3D-AE0C-30CF899358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F929CDD-4FDD-E605-B90D-B4B14694F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7E43FAB-B13E-EF24-154E-CD636FA67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DE07-21A0-4561-A9C8-47887C3BA2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1770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A80413-ED35-2721-997F-44905C051B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AECDBBD-B249-3592-A912-25D24FC601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C61D18F-2124-AF22-308A-2589BFDE2D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02001EB-16C6-61E3-361A-AD8FF8E860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30EDFEE-77AD-841E-DF4A-C6EA0E8E72A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1422AB0-98F2-FDD9-AEFC-8E45EFB00F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DF163-5251-4D3D-AE0C-30CF899358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545FFE6-2B26-E247-1401-3FAFA5825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2FF17EC-7690-26C1-9590-D94417CD9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DE07-21A0-4561-A9C8-47887C3BA2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9476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0773748-693F-A758-1522-A11E3226FF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B8F9209-9C5B-E07F-9E51-6E8AFC598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DF163-5251-4D3D-AE0C-30CF899358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FD093B7-E12E-4D63-2EF6-EF0AD08AC2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83A8E29-6B94-003B-5D06-3733842574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DE07-21A0-4561-A9C8-47887C3BA2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1762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6736BEE-7A50-6C36-7390-C9DD24C084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DF163-5251-4D3D-AE0C-30CF899358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F337DA0-95EE-018F-6E8E-9752CBABE9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A53FEED-D35B-7BA3-8FBA-D82896081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DE07-21A0-4561-A9C8-47887C3BA2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48534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8173F3-62C4-9029-E386-0BDA0D0864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2FAF313-9F80-2B1F-34E6-FF035B6F81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48331D8-48B5-EEE4-FCA8-7A5CD7634F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0A26768-3315-AF90-5F49-D5E49BFA8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DF163-5251-4D3D-AE0C-30CF899358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0C4DBFB-4694-2275-D872-4B8EBB0B8C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BBFDA6E-B0B7-3E86-95C3-19027AC327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DE07-21A0-4561-A9C8-47887C3BA2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31108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21A14B3-5014-D9DE-D393-38D39980F9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C7036A3-AFFB-75CC-A4D3-7BA0E5D332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76D82FC-93E4-4FB0-3BBD-99A1DE2AC3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E80BE5F-7157-D6D4-6069-3D8E7CBAA7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DF163-5251-4D3D-AE0C-30CF899358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932C19A-A1D1-1842-C40A-A770AE1878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23806F2-0F3E-5491-1F5D-CDF57F1FCF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1CDE07-21A0-4561-A9C8-47887C3BA2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5108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E1DD2E5-57D5-C7AA-2D46-27B8CCD4B7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A0AF6AA-254A-702B-E2A4-72D3E9BD0F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C28A466-FB29-F6ED-7630-D3287F38F6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FDF163-5251-4D3D-AE0C-30CF89935846}" type="datetimeFigureOut">
              <a:rPr kumimoji="1" lang="ja-JP" altLang="en-US" smtClean="0"/>
              <a:t>2023/4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B63AF9C-5D2F-B3F8-CA89-127FDF4ABC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16E7E7F-2969-293B-B6BD-FDD4FE5C900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1CDE07-21A0-4561-A9C8-47887C3BA2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9741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建物 が含まれている画像&#10;&#10;自動的に生成された説明">
            <a:extLst>
              <a:ext uri="{FF2B5EF4-FFF2-40B4-BE49-F238E27FC236}">
                <a16:creationId xmlns:a16="http://schemas.microsoft.com/office/drawing/2014/main" id="{78327510-125C-1C77-AE2A-D9864BC4B3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1925053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F33B4C2-3439-C692-B917-8E129293DCCB}"/>
              </a:ext>
            </a:extLst>
          </p:cNvPr>
          <p:cNvSpPr txBox="1"/>
          <p:nvPr/>
        </p:nvSpPr>
        <p:spPr>
          <a:xfrm>
            <a:off x="1828800" y="777860"/>
            <a:ext cx="89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X1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430D103A-412D-7BD9-FE93-FA69E39922C6}"/>
              </a:ext>
            </a:extLst>
          </p:cNvPr>
          <p:cNvCxnSpPr/>
          <p:nvPr/>
        </p:nvCxnSpPr>
        <p:spPr>
          <a:xfrm>
            <a:off x="355235" y="1925053"/>
            <a:ext cx="89466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図 9" descr="回路 が含まれている画像&#10;&#10;自動的に生成された説明">
            <a:extLst>
              <a:ext uri="{FF2B5EF4-FFF2-40B4-BE49-F238E27FC236}">
                <a16:creationId xmlns:a16="http://schemas.microsoft.com/office/drawing/2014/main" id="{CB1D29FB-0793-7145-F563-65753C611FB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93946"/>
            <a:ext cx="12192000" cy="1925053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74C98CA-A96F-0B56-3F7F-004D33FE6B9C}"/>
              </a:ext>
            </a:extLst>
          </p:cNvPr>
          <p:cNvSpPr txBox="1"/>
          <p:nvPr/>
        </p:nvSpPr>
        <p:spPr>
          <a:xfrm>
            <a:off x="1828800" y="2771806"/>
            <a:ext cx="89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X2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41A69071-77D4-DA02-2A8E-E6AB95F0AE39}"/>
              </a:ext>
            </a:extLst>
          </p:cNvPr>
          <p:cNvCxnSpPr/>
          <p:nvPr/>
        </p:nvCxnSpPr>
        <p:spPr>
          <a:xfrm>
            <a:off x="374024" y="3624417"/>
            <a:ext cx="89466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図 13" descr="テーブル が含まれている画像&#10;&#10;自動的に生成された説明">
            <a:extLst>
              <a:ext uri="{FF2B5EF4-FFF2-40B4-BE49-F238E27FC236}">
                <a16:creationId xmlns:a16="http://schemas.microsoft.com/office/drawing/2014/main" id="{3D9CCADD-CF35-DD89-F0B2-7F8AA9890F9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987890"/>
            <a:ext cx="12192000" cy="1925053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2BA0546-90F7-E92F-B289-A842EBF87E4F}"/>
              </a:ext>
            </a:extLst>
          </p:cNvPr>
          <p:cNvSpPr txBox="1"/>
          <p:nvPr/>
        </p:nvSpPr>
        <p:spPr>
          <a:xfrm>
            <a:off x="1828800" y="4765750"/>
            <a:ext cx="89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X3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7BBA01AE-223E-AD1A-DE70-2C42F17289C9}"/>
              </a:ext>
            </a:extLst>
          </p:cNvPr>
          <p:cNvCxnSpPr/>
          <p:nvPr/>
        </p:nvCxnSpPr>
        <p:spPr>
          <a:xfrm>
            <a:off x="419953" y="5687036"/>
            <a:ext cx="89466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0523FD6-3486-E5E8-9FD5-96DB6EF78E62}"/>
              </a:ext>
            </a:extLst>
          </p:cNvPr>
          <p:cNvSpPr txBox="1"/>
          <p:nvPr/>
        </p:nvSpPr>
        <p:spPr>
          <a:xfrm>
            <a:off x="0" y="5912943"/>
            <a:ext cx="12192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1. </a:t>
            </a:r>
          </a:p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s for 13 protein-coding genes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ss the mitochondrial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ome of </a:t>
            </a:r>
            <a:r>
              <a:rPr kumimoji="1"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urilla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ziliana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ose of 22 previously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racterized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udibranch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cies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1059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建物 が含まれている画像&#10;&#10;自動的に生成された説明">
            <a:extLst>
              <a:ext uri="{FF2B5EF4-FFF2-40B4-BE49-F238E27FC236}">
                <a16:creationId xmlns:a16="http://schemas.microsoft.com/office/drawing/2014/main" id="{E24BCB50-AC8D-E5A5-0C5C-403874BE184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1925053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A341608-9CF1-86FD-DCFC-461648F836AA}"/>
              </a:ext>
            </a:extLst>
          </p:cNvPr>
          <p:cNvSpPr txBox="1"/>
          <p:nvPr/>
        </p:nvSpPr>
        <p:spPr>
          <a:xfrm>
            <a:off x="1797485" y="777860"/>
            <a:ext cx="89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B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7B13BFF1-939D-1F84-042B-B67C1EF57818}"/>
              </a:ext>
            </a:extLst>
          </p:cNvPr>
          <p:cNvCxnSpPr/>
          <p:nvPr/>
        </p:nvCxnSpPr>
        <p:spPr>
          <a:xfrm>
            <a:off x="355235" y="1774741"/>
            <a:ext cx="89466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図 8" descr="回路 が含まれている画像&#10;&#10;自動的に生成された説明">
            <a:extLst>
              <a:ext uri="{FF2B5EF4-FFF2-40B4-BE49-F238E27FC236}">
                <a16:creationId xmlns:a16="http://schemas.microsoft.com/office/drawing/2014/main" id="{5AA50CD4-0834-0E0D-FC34-A117F6F4525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25052"/>
            <a:ext cx="12192000" cy="1925053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ED5FD78-5CE8-839A-EC8F-CEC9E2DB7547}"/>
              </a:ext>
            </a:extLst>
          </p:cNvPr>
          <p:cNvSpPr txBox="1"/>
          <p:nvPr/>
        </p:nvSpPr>
        <p:spPr>
          <a:xfrm>
            <a:off x="1797485" y="2702912"/>
            <a:ext cx="89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6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E6759317-408C-4BFB-CF7D-4CDB5E16129F}"/>
              </a:ext>
            </a:extLst>
          </p:cNvPr>
          <p:cNvCxnSpPr/>
          <p:nvPr/>
        </p:nvCxnSpPr>
        <p:spPr>
          <a:xfrm>
            <a:off x="438742" y="3618155"/>
            <a:ext cx="89466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図 12" descr="挿絵 が含まれている画像&#10;&#10;自動的に生成された説明">
            <a:extLst>
              <a:ext uri="{FF2B5EF4-FFF2-40B4-BE49-F238E27FC236}">
                <a16:creationId xmlns:a16="http://schemas.microsoft.com/office/drawing/2014/main" id="{440A2D3E-DFDD-142B-D0D0-BA327EE36F3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530" y="3900050"/>
            <a:ext cx="6959806" cy="1925052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3D511CA-201B-12BE-B5DE-8CC70F107061}"/>
              </a:ext>
            </a:extLst>
          </p:cNvPr>
          <p:cNvSpPr txBox="1"/>
          <p:nvPr/>
        </p:nvSpPr>
        <p:spPr>
          <a:xfrm>
            <a:off x="1797485" y="4677910"/>
            <a:ext cx="89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P8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C27653D6-063A-702B-CA38-6EF77764FCAE}"/>
              </a:ext>
            </a:extLst>
          </p:cNvPr>
          <p:cNvCxnSpPr/>
          <p:nvPr/>
        </p:nvCxnSpPr>
        <p:spPr>
          <a:xfrm>
            <a:off x="438742" y="5524199"/>
            <a:ext cx="89466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F605C4E-FC6E-AA61-2F8D-B48983AE7F64}"/>
              </a:ext>
            </a:extLst>
          </p:cNvPr>
          <p:cNvSpPr txBox="1"/>
          <p:nvPr/>
        </p:nvSpPr>
        <p:spPr>
          <a:xfrm>
            <a:off x="0" y="5912943"/>
            <a:ext cx="12192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1. </a:t>
            </a:r>
          </a:p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s for 13 protein-coding genes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ss the mitochondrial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ome of </a:t>
            </a:r>
            <a:r>
              <a:rPr kumimoji="1"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urilla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ziliana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ose of 22 previously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racterized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udibranch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cies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178670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コンピュータ が含まれている画像&#10;&#10;自動的に生成された説明">
            <a:extLst>
              <a:ext uri="{FF2B5EF4-FFF2-40B4-BE49-F238E27FC236}">
                <a16:creationId xmlns:a16="http://schemas.microsoft.com/office/drawing/2014/main" id="{77EB9B98-7532-27CE-7486-B88D5FB713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1925053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4D2D0C4-1E20-2D0D-85A0-52968DDD97B1}"/>
              </a:ext>
            </a:extLst>
          </p:cNvPr>
          <p:cNvSpPr txBox="1"/>
          <p:nvPr/>
        </p:nvSpPr>
        <p:spPr>
          <a:xfrm>
            <a:off x="1771171" y="777860"/>
            <a:ext cx="89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1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2FA12C99-D554-D7A9-B1CC-67428089D5CC}"/>
              </a:ext>
            </a:extLst>
          </p:cNvPr>
          <p:cNvCxnSpPr/>
          <p:nvPr/>
        </p:nvCxnSpPr>
        <p:spPr>
          <a:xfrm>
            <a:off x="328923" y="1774741"/>
            <a:ext cx="89466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図 8" descr="コンピュータ が含まれている画像&#10;&#10;自動的に生成された説明">
            <a:extLst>
              <a:ext uri="{FF2B5EF4-FFF2-40B4-BE49-F238E27FC236}">
                <a16:creationId xmlns:a16="http://schemas.microsoft.com/office/drawing/2014/main" id="{42B19DB9-79E0-8C3E-6C58-42CB66CD3F8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25052"/>
            <a:ext cx="12192000" cy="1925053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2D60FF9-C5DE-DC9E-8C1D-0BD3CD71CB9C}"/>
              </a:ext>
            </a:extLst>
          </p:cNvPr>
          <p:cNvSpPr txBox="1"/>
          <p:nvPr/>
        </p:nvSpPr>
        <p:spPr>
          <a:xfrm>
            <a:off x="1771171" y="2702912"/>
            <a:ext cx="89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2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80250E2A-E7D4-4C7E-4AEF-D7F0E1BC9E34}"/>
              </a:ext>
            </a:extLst>
          </p:cNvPr>
          <p:cNvCxnSpPr/>
          <p:nvPr/>
        </p:nvCxnSpPr>
        <p:spPr>
          <a:xfrm>
            <a:off x="270813" y="3196775"/>
            <a:ext cx="89466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図 12" descr="回路 が含まれている画像&#10;&#10;自動的に生成された説明">
            <a:extLst>
              <a:ext uri="{FF2B5EF4-FFF2-40B4-BE49-F238E27FC236}">
                <a16:creationId xmlns:a16="http://schemas.microsoft.com/office/drawing/2014/main" id="{1797BF1E-F622-72BA-1EBF-3202F8A7C80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50104"/>
            <a:ext cx="11199315" cy="1925054"/>
          </a:xfrm>
          <a:prstGeom prst="rect">
            <a:avLst/>
          </a:prstGeom>
        </p:spPr>
      </p:pic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2A9A019F-3ABA-30B4-676C-15BEC3204B27}"/>
              </a:ext>
            </a:extLst>
          </p:cNvPr>
          <p:cNvCxnSpPr/>
          <p:nvPr/>
        </p:nvCxnSpPr>
        <p:spPr>
          <a:xfrm>
            <a:off x="348657" y="5618730"/>
            <a:ext cx="89466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21917C5-71BC-9C03-1CD0-B7F7DEDA44E2}"/>
              </a:ext>
            </a:extLst>
          </p:cNvPr>
          <p:cNvSpPr txBox="1"/>
          <p:nvPr/>
        </p:nvSpPr>
        <p:spPr>
          <a:xfrm>
            <a:off x="1771171" y="4628243"/>
            <a:ext cx="89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3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5E25A04-815E-AEE7-E918-DACA78BF0663}"/>
              </a:ext>
            </a:extLst>
          </p:cNvPr>
          <p:cNvSpPr txBox="1"/>
          <p:nvPr/>
        </p:nvSpPr>
        <p:spPr>
          <a:xfrm>
            <a:off x="0" y="5912943"/>
            <a:ext cx="12192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1. </a:t>
            </a:r>
          </a:p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s for 13 protein-coding genes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ss the mitochondrial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ome of </a:t>
            </a:r>
            <a:r>
              <a:rPr kumimoji="1"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urilla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ziliana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ose of 22 previously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racterized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udibranch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cies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25030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パソコンの画面&#10;&#10;低い精度で自動的に生成された説明">
            <a:extLst>
              <a:ext uri="{FF2B5EF4-FFF2-40B4-BE49-F238E27FC236}">
                <a16:creationId xmlns:a16="http://schemas.microsoft.com/office/drawing/2014/main" id="{A62623DD-B2C9-CCB7-3F77-3D8AAF235F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1925053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848C5D5-D6AB-9AF5-EF24-0A620A1D1E1A}"/>
              </a:ext>
            </a:extLst>
          </p:cNvPr>
          <p:cNvSpPr txBox="1"/>
          <p:nvPr/>
        </p:nvSpPr>
        <p:spPr>
          <a:xfrm>
            <a:off x="1764593" y="777860"/>
            <a:ext cx="89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4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図 7" descr="回路 が含まれている画像&#10;&#10;自動的に生成された説明">
            <a:extLst>
              <a:ext uri="{FF2B5EF4-FFF2-40B4-BE49-F238E27FC236}">
                <a16:creationId xmlns:a16="http://schemas.microsoft.com/office/drawing/2014/main" id="{97207534-671C-DD2E-54BA-829A5159D5A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25052"/>
            <a:ext cx="9196627" cy="1899951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A2C2DA3-E28C-8863-7622-55B6595A66D6}"/>
              </a:ext>
            </a:extLst>
          </p:cNvPr>
          <p:cNvSpPr txBox="1"/>
          <p:nvPr/>
        </p:nvSpPr>
        <p:spPr>
          <a:xfrm>
            <a:off x="1764593" y="2690361"/>
            <a:ext cx="89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4L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3CDBBAC0-6FA0-B591-1CB0-645B766C5F77}"/>
              </a:ext>
            </a:extLst>
          </p:cNvPr>
          <p:cNvCxnSpPr/>
          <p:nvPr/>
        </p:nvCxnSpPr>
        <p:spPr>
          <a:xfrm>
            <a:off x="328922" y="1925052"/>
            <a:ext cx="89466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33500CCE-0D0B-0C59-9520-5724D1E499FC}"/>
              </a:ext>
            </a:extLst>
          </p:cNvPr>
          <p:cNvCxnSpPr/>
          <p:nvPr/>
        </p:nvCxnSpPr>
        <p:spPr>
          <a:xfrm>
            <a:off x="381549" y="3825003"/>
            <a:ext cx="89466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図 12" descr="布 が含まれている画像&#10;&#10;自動的に生成された説明">
            <a:extLst>
              <a:ext uri="{FF2B5EF4-FFF2-40B4-BE49-F238E27FC236}">
                <a16:creationId xmlns:a16="http://schemas.microsoft.com/office/drawing/2014/main" id="{23DACBDF-E687-FCEA-2B86-377FCEF83A2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48101"/>
            <a:ext cx="12192000" cy="1853754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ED8A6A1-9D01-CBD8-E7D1-800BEB3F3ECD}"/>
              </a:ext>
            </a:extLst>
          </p:cNvPr>
          <p:cNvSpPr txBox="1"/>
          <p:nvPr/>
        </p:nvSpPr>
        <p:spPr>
          <a:xfrm>
            <a:off x="1764593" y="4590311"/>
            <a:ext cx="89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5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31415FF3-2792-603C-EC93-F6E00B78C4CF}"/>
              </a:ext>
            </a:extLst>
          </p:cNvPr>
          <p:cNvCxnSpPr/>
          <p:nvPr/>
        </p:nvCxnSpPr>
        <p:spPr>
          <a:xfrm>
            <a:off x="435273" y="5260194"/>
            <a:ext cx="89466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247F0E5-13AF-A0E1-6DD9-0A1B23A6032F}"/>
              </a:ext>
            </a:extLst>
          </p:cNvPr>
          <p:cNvSpPr txBox="1"/>
          <p:nvPr/>
        </p:nvSpPr>
        <p:spPr>
          <a:xfrm>
            <a:off x="0" y="5912943"/>
            <a:ext cx="12192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1. </a:t>
            </a:r>
          </a:p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s for 13 protein-coding genes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ss the mitochondrial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ome of </a:t>
            </a:r>
            <a:r>
              <a:rPr kumimoji="1"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urilla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ziliana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ose of 22 previously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racterized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udibranch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cies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10011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回路 が含まれている画像&#10;&#10;自動的に生成された説明">
            <a:extLst>
              <a:ext uri="{FF2B5EF4-FFF2-40B4-BE49-F238E27FC236}">
                <a16:creationId xmlns:a16="http://schemas.microsoft.com/office/drawing/2014/main" id="{20A9F7E2-FFA7-473B-0450-E7C134A6319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1925053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3AA6F79-97C9-9FA5-9955-BC0E07501F68}"/>
              </a:ext>
            </a:extLst>
          </p:cNvPr>
          <p:cNvSpPr txBox="1"/>
          <p:nvPr/>
        </p:nvSpPr>
        <p:spPr>
          <a:xfrm>
            <a:off x="1804063" y="777860"/>
            <a:ext cx="8946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6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8DF07522-164D-22BD-8EA1-778DFEE75AEB}"/>
              </a:ext>
            </a:extLst>
          </p:cNvPr>
          <p:cNvCxnSpPr/>
          <p:nvPr/>
        </p:nvCxnSpPr>
        <p:spPr>
          <a:xfrm>
            <a:off x="330018" y="1556545"/>
            <a:ext cx="894664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D268CE8-423F-13A4-DE8D-6A1D6D6709B6}"/>
              </a:ext>
            </a:extLst>
          </p:cNvPr>
          <p:cNvSpPr txBox="1"/>
          <p:nvPr/>
        </p:nvSpPr>
        <p:spPr>
          <a:xfrm>
            <a:off x="0" y="5912943"/>
            <a:ext cx="121920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1. </a:t>
            </a:r>
          </a:p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s for 13 protein-coding genes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oss the mitochondrial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ome of </a:t>
            </a:r>
            <a:r>
              <a:rPr kumimoji="1"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urilla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ziliana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ose of 22 previously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racterized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udibranch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cies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49180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138</Words>
  <Application>Microsoft Office PowerPoint</Application>
  <PresentationFormat>ワイド画面</PresentationFormat>
  <Paragraphs>23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溝端 秀彬</dc:creator>
  <cp:lastModifiedBy>溝端 秀彬</cp:lastModifiedBy>
  <cp:revision>2</cp:revision>
  <dcterms:created xsi:type="dcterms:W3CDTF">2023-04-06T23:08:22Z</dcterms:created>
  <dcterms:modified xsi:type="dcterms:W3CDTF">2023-04-06T23:47:08Z</dcterms:modified>
</cp:coreProperties>
</file>